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03" userDrawn="1">
          <p15:clr>
            <a:srgbClr val="A4A3A4"/>
          </p15:clr>
        </p15:guide>
        <p15:guide id="2" pos="58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4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2" y="144"/>
      </p:cViewPr>
      <p:guideLst>
        <p:guide orient="horz" pos="3203"/>
        <p:guide pos="58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33387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9440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67784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5800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89395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94641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9437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4382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0514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53663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05502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ED240-0DFB-4D72-AE05-4E73D8EE2837}" type="datetimeFigureOut">
              <a:rPr lang="en-CA" smtClean="0"/>
              <a:t>2024-03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749C1-6A9E-42D9-9CF1-490A9A7876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2425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50392" y="621792"/>
            <a:ext cx="9295795" cy="5243995"/>
            <a:chOff x="850392" y="621792"/>
            <a:chExt cx="9295795" cy="524399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44800" y="1008000"/>
              <a:ext cx="1603387" cy="1603387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68400" y="1008000"/>
              <a:ext cx="1597290" cy="159729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95600" y="1008000"/>
              <a:ext cx="1597290" cy="1603387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922800" y="1008000"/>
              <a:ext cx="1603387" cy="1603387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546400" y="1008000"/>
              <a:ext cx="1597290" cy="1603387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044800" y="2638800"/>
              <a:ext cx="1603387" cy="159729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68400" y="2638800"/>
              <a:ext cx="1603387" cy="159729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295600" y="2638800"/>
              <a:ext cx="1603387" cy="159729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919200" y="2638800"/>
              <a:ext cx="1597290" cy="159729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542800" y="2638800"/>
              <a:ext cx="1603387" cy="159729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044800" y="4262400"/>
              <a:ext cx="1603387" cy="1603387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668400" y="4262400"/>
              <a:ext cx="1603387" cy="159729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295600" y="4262400"/>
              <a:ext cx="1603387" cy="1603387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6919200" y="4262400"/>
              <a:ext cx="1597290" cy="1597290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8542800" y="4262400"/>
              <a:ext cx="1603387" cy="1597290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2425459" y="621792"/>
              <a:ext cx="882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× MES</a:t>
              </a:r>
              <a:endParaRPr lang="en-US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806893" y="621792"/>
              <a:ext cx="13019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50 </a:t>
              </a:r>
              <a:r>
                <a:rPr lang="en-US" dirty="0" err="1" smtClean="0"/>
                <a:t>mM</a:t>
              </a:r>
              <a:r>
                <a:rPr lang="en-US" dirty="0" smtClean="0"/>
                <a:t> GSH</a:t>
              </a:r>
              <a:endParaRPr lang="en-US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389567" y="621792"/>
              <a:ext cx="14189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00 </a:t>
              </a:r>
              <a:r>
                <a:rPr lang="en-US" dirty="0" err="1" smtClean="0"/>
                <a:t>mM</a:t>
              </a:r>
              <a:r>
                <a:rPr lang="en-US" dirty="0" smtClean="0"/>
                <a:t> GSH</a:t>
              </a:r>
              <a:endParaRPr lang="en-US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025079" y="621792"/>
              <a:ext cx="14189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50 </a:t>
              </a:r>
              <a:r>
                <a:rPr lang="en-US" dirty="0" err="1" smtClean="0"/>
                <a:t>mM</a:t>
              </a:r>
              <a:r>
                <a:rPr lang="en-US" dirty="0" smtClean="0"/>
                <a:t> GSH</a:t>
              </a:r>
              <a:endParaRPr 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638289" y="621792"/>
              <a:ext cx="14189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200 </a:t>
              </a:r>
              <a:r>
                <a:rPr lang="en-US" dirty="0" err="1" smtClean="0"/>
                <a:t>mM</a:t>
              </a:r>
              <a:r>
                <a:rPr lang="en-US" dirty="0" smtClean="0"/>
                <a:t> GSH</a:t>
              </a:r>
              <a:endParaRPr lang="en-US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50392" y="1492581"/>
              <a:ext cx="123597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Weed-free </a:t>
              </a:r>
            </a:p>
            <a:p>
              <a:pPr algn="ctr"/>
              <a:r>
                <a:rPr lang="en-US" dirty="0" smtClean="0"/>
                <a:t>control</a:t>
              </a:r>
              <a:endParaRPr lang="en-U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950976" y="3157648"/>
              <a:ext cx="108042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Biological</a:t>
              </a:r>
            </a:p>
            <a:p>
              <a:pPr algn="ctr"/>
              <a:r>
                <a:rPr lang="en-US" dirty="0"/>
                <a:t>l</a:t>
              </a:r>
              <a:r>
                <a:rPr lang="en-US" dirty="0" smtClean="0"/>
                <a:t>ow R:FR</a:t>
              </a:r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051560" y="4747886"/>
              <a:ext cx="99488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Artificial</a:t>
              </a:r>
            </a:p>
            <a:p>
              <a:pPr algn="ctr"/>
              <a:r>
                <a:rPr lang="en-US" dirty="0"/>
                <a:t>l</a:t>
              </a:r>
              <a:r>
                <a:rPr lang="en-US" dirty="0" smtClean="0"/>
                <a:t>ow R:FR</a:t>
              </a:r>
              <a:endParaRPr lang="en-US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001600" y="9504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A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620590" y="95097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B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249093" y="95097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C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877599" y="950400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D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506105" y="950976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E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002536" y="2577600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F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621024" y="2578608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G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248656" y="2578608"/>
              <a:ext cx="3289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H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876288" y="2578608"/>
              <a:ext cx="2423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I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503920" y="2578608"/>
              <a:ext cx="258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J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002536" y="4204800"/>
              <a:ext cx="3048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</a:rPr>
                <a:t>K</a:t>
              </a:r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621024" y="420406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246481" y="4206240"/>
              <a:ext cx="3818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876288" y="4206240"/>
              <a:ext cx="333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N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503920" y="4206240"/>
              <a:ext cx="3369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O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3268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38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an Amirsadeghi</dc:creator>
  <cp:lastModifiedBy>Sasan Amirsadeghi</cp:lastModifiedBy>
  <cp:revision>5</cp:revision>
  <dcterms:created xsi:type="dcterms:W3CDTF">2024-03-18T17:40:13Z</dcterms:created>
  <dcterms:modified xsi:type="dcterms:W3CDTF">2024-03-18T18:07:10Z</dcterms:modified>
</cp:coreProperties>
</file>